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5" r:id="rId2"/>
    <p:sldId id="277" r:id="rId3"/>
    <p:sldId id="279" r:id="rId4"/>
    <p:sldId id="286" r:id="rId5"/>
    <p:sldId id="287" r:id="rId6"/>
    <p:sldId id="284" r:id="rId7"/>
    <p:sldId id="283" r:id="rId8"/>
    <p:sldId id="289" r:id="rId9"/>
    <p:sldId id="290" r:id="rId10"/>
    <p:sldId id="291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4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LL\Downloads\Book1202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[Book12024.xlsx]Sheet1!$E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[Book12024.xlsx]Sheet1!$G$3:$G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0000000000000005E-3</c:v>
                  </c:pt>
                  <c:pt idx="2">
                    <c:v>1.0000000000000005E-3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[Book12024.xlsx]Sheet1!$G$3:$G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0000000000000005E-3</c:v>
                  </c:pt>
                  <c:pt idx="2">
                    <c:v>1.0000000000000005E-3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Book12024.xlsx]Sheet1!$D$3:$D$10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cat>
          <c:val>
            <c:numRef>
              <c:f>[Book12024.xlsx]Sheet1!$E$3:$E$10</c:f>
              <c:numCache>
                <c:formatCode>0.0000</c:formatCode>
                <c:ptCount val="8"/>
                <c:pt idx="0">
                  <c:v>0.81699999999999995</c:v>
                </c:pt>
                <c:pt idx="1">
                  <c:v>0.80100000000000005</c:v>
                </c:pt>
                <c:pt idx="2">
                  <c:v>0.82000000000000017</c:v>
                </c:pt>
                <c:pt idx="3">
                  <c:v>0.81200000000000028</c:v>
                </c:pt>
                <c:pt idx="4">
                  <c:v>0.82399999999999995</c:v>
                </c:pt>
                <c:pt idx="5">
                  <c:v>0.81699999999999995</c:v>
                </c:pt>
                <c:pt idx="6">
                  <c:v>0.82900000000000018</c:v>
                </c:pt>
                <c:pt idx="7">
                  <c:v>0.820000000000000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71-4BB8-BF35-1A3A612F3D5C}"/>
            </c:ext>
          </c:extLst>
        </c:ser>
        <c:gapWidth val="219"/>
        <c:overlap val="-27"/>
        <c:axId val="76232960"/>
        <c:axId val="76236288"/>
      </c:barChart>
      <c:catAx>
        <c:axId val="7623296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236288"/>
        <c:crosses val="autoZero"/>
        <c:auto val="1"/>
        <c:lblAlgn val="ctr"/>
        <c:lblOffset val="100"/>
      </c:catAx>
      <c:valAx>
        <c:axId val="76236288"/>
        <c:scaling>
          <c:orientation val="minMax"/>
          <c:min val="0.8"/>
        </c:scaling>
        <c:axPos val="l"/>
        <c:numFmt formatCode="0.000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232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1C8FE7-46CB-409B-B511-2E483735029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47FFF6-4F51-42A5-AEAB-270B30F4C55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240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857960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339525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008530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8358809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0324947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8687539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8687539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065590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8806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9679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9817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78390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07997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03762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81252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45539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78306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0119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7680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57085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35256" y="0"/>
            <a:ext cx="9032543" cy="623887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657600" y="5806223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5257" y="6211669"/>
            <a:ext cx="9032542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1).</a:t>
            </a:r>
          </a:p>
        </p:txBody>
      </p:sp>
    </p:spTree>
    <p:extLst>
      <p:ext uri="{BB962C8B-B14F-4D97-AF65-F5344CB8AC3E}">
        <p14:creationId xmlns="" xmlns:p14="http://schemas.microsoft.com/office/powerpoint/2010/main" val="13210302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="" xmlns:a16="http://schemas.microsoft.com/office/drawing/2014/main" id="{B00C76F5-EE91-BCEC-80CB-76F1BFC405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74886007"/>
              </p:ext>
            </p:extLst>
          </p:nvPr>
        </p:nvGraphicFramePr>
        <p:xfrm>
          <a:off x="381000" y="609600"/>
          <a:ext cx="853440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81000" y="5401270"/>
            <a:ext cx="8497324" cy="92333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J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 Bar graph showing the mean values of chlorophyll content and photosystem-II activity for whole plant  canopy of  ICC-9085 of under ambient / treatment (T-1 to T-8) reflecting superiority of T-7.</a:t>
            </a:r>
          </a:p>
        </p:txBody>
      </p:sp>
    </p:spTree>
    <p:extLst>
      <p:ext uri="{BB962C8B-B14F-4D97-AF65-F5344CB8AC3E}">
        <p14:creationId xmlns="" xmlns:p14="http://schemas.microsoft.com/office/powerpoint/2010/main" val="2939184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4549" y="-20472"/>
            <a:ext cx="8987052" cy="611647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37878" y="56504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" y="6096000"/>
            <a:ext cx="89916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2).</a:t>
            </a:r>
          </a:p>
        </p:txBody>
      </p:sp>
    </p:spTree>
    <p:extLst>
      <p:ext uri="{BB962C8B-B14F-4D97-AF65-F5344CB8AC3E}">
        <p14:creationId xmlns="" xmlns:p14="http://schemas.microsoft.com/office/powerpoint/2010/main" val="1440408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31845" y="-30707"/>
            <a:ext cx="9035956" cy="600657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728053" y="55249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1845" y="6007821"/>
            <a:ext cx="9026124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3).</a:t>
            </a:r>
          </a:p>
        </p:txBody>
      </p:sp>
    </p:spTree>
    <p:extLst>
      <p:ext uri="{BB962C8B-B14F-4D97-AF65-F5344CB8AC3E}">
        <p14:creationId xmlns="" xmlns:p14="http://schemas.microsoft.com/office/powerpoint/2010/main" val="3305913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3"/>
          <a:stretch>
            <a:fillRect/>
          </a:stretch>
        </p:blipFill>
        <p:spPr>
          <a:xfrm>
            <a:off x="94761" y="76200"/>
            <a:ext cx="8915400" cy="5943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36277" y="55626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6199" y="6096000"/>
            <a:ext cx="8915399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4).</a:t>
            </a:r>
          </a:p>
        </p:txBody>
      </p:sp>
    </p:spTree>
    <p:extLst>
      <p:ext uri="{BB962C8B-B14F-4D97-AF65-F5344CB8AC3E}">
        <p14:creationId xmlns="" xmlns:p14="http://schemas.microsoft.com/office/powerpoint/2010/main" val="11342798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76200" y="152400"/>
            <a:ext cx="8915400" cy="600813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72076" y="57912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6200" y="6172200"/>
            <a:ext cx="89154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E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5).</a:t>
            </a:r>
          </a:p>
        </p:txBody>
      </p:sp>
    </p:spTree>
    <p:extLst>
      <p:ext uri="{BB962C8B-B14F-4D97-AF65-F5344CB8AC3E}">
        <p14:creationId xmlns="" xmlns:p14="http://schemas.microsoft.com/office/powerpoint/2010/main" val="13270064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-25021"/>
            <a:ext cx="9067800" cy="600088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657600" y="54864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6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0" y="6019800"/>
            <a:ext cx="90678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F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6).</a:t>
            </a:r>
          </a:p>
        </p:txBody>
      </p:sp>
    </p:spTree>
    <p:extLst>
      <p:ext uri="{BB962C8B-B14F-4D97-AF65-F5344CB8AC3E}">
        <p14:creationId xmlns="" xmlns:p14="http://schemas.microsoft.com/office/powerpoint/2010/main" val="24669377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-25021"/>
            <a:ext cx="9067800" cy="619722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38600" y="57266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7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0" y="6211669"/>
            <a:ext cx="90678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G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7).</a:t>
            </a:r>
          </a:p>
        </p:txBody>
      </p:sp>
    </p:spTree>
    <p:extLst>
      <p:ext uri="{BB962C8B-B14F-4D97-AF65-F5344CB8AC3E}">
        <p14:creationId xmlns="" xmlns:p14="http://schemas.microsoft.com/office/powerpoint/2010/main" val="24669377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18197"/>
            <a:ext cx="9067800" cy="615400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757377" y="58028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8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0" y="6211669"/>
            <a:ext cx="90678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H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9085 under ambient / treatment (T-8).</a:t>
            </a:r>
          </a:p>
        </p:txBody>
      </p:sp>
    </p:spTree>
    <p:extLst>
      <p:ext uri="{BB962C8B-B14F-4D97-AF65-F5344CB8AC3E}">
        <p14:creationId xmlns="" xmlns:p14="http://schemas.microsoft.com/office/powerpoint/2010/main" val="5666130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57200" y="609600"/>
            <a:ext cx="8177468" cy="92333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/ Data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I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 Basics statistics of chlorophyll content and photosystem-II activity for whole plant canopy of ICC-9085 under ambient / treatment (T-1 to T-8).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568096732"/>
              </p:ext>
            </p:extLst>
          </p:nvPr>
        </p:nvGraphicFramePr>
        <p:xfrm>
          <a:off x="533398" y="1828800"/>
          <a:ext cx="8101268" cy="43434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34192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4192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34192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39162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341928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341928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eatment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in. 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ax.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ean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.D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.E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17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2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0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07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3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03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4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12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04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5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4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02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6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17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05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7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8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3831926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336</Words>
  <Application>Microsoft Office PowerPoint</Application>
  <PresentationFormat>On-screen Show (4:3)</PresentationFormat>
  <Paragraphs>82</Paragraphs>
  <Slides>10</Slides>
  <Notes>8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CC-1083</dc:title>
  <dc:creator>DELL</dc:creator>
  <cp:lastModifiedBy>DELL</cp:lastModifiedBy>
  <cp:revision>16</cp:revision>
  <dcterms:created xsi:type="dcterms:W3CDTF">2024-07-19T13:46:24Z</dcterms:created>
  <dcterms:modified xsi:type="dcterms:W3CDTF">2025-07-14T11:55:55Z</dcterms:modified>
</cp:coreProperties>
</file>